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13480677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一樹 野田" initials="一野" lastIdx="2" clrIdx="0">
    <p:extLst>
      <p:ext uri="{19B8F6BF-5375-455C-9EA6-DF929625EA0E}">
        <p15:presenceInfo xmlns:p15="http://schemas.microsoft.com/office/powerpoint/2012/main" userId="17b979a6b5b904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9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08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78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0mb1\OneDrive\Documents\&#23398;&#20250;&#12539;&#35542;&#25991;&#12539;&#30330;&#34920;\ICE%20study&#38306;&#36899;\&#20877;&#35299;&#26512;&#29992;\RFCA%20&#12487;&#12540;&#12479;&#12505;&#12540;&#12473;%20&#20877;&#35299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4PV比較'!$I$2</c:f>
              <c:strCache>
                <c:ptCount val="1"/>
                <c:pt idx="0">
                  <c:v>Pt 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4PV比較'!$J$1:$M$1</c:f>
              <c:strCache>
                <c:ptCount val="4"/>
                <c:pt idx="0">
                  <c:v>RSPV</c:v>
                </c:pt>
                <c:pt idx="1">
                  <c:v>RIPV</c:v>
                </c:pt>
                <c:pt idx="2">
                  <c:v>LSPV</c:v>
                </c:pt>
                <c:pt idx="3">
                  <c:v>LIPV</c:v>
                </c:pt>
              </c:strCache>
            </c:strRef>
          </c:cat>
          <c:val>
            <c:numRef>
              <c:f>'4PV比較'!$J$2:$M$2</c:f>
              <c:numCache>
                <c:formatCode>General</c:formatCode>
                <c:ptCount val="4"/>
                <c:pt idx="0">
                  <c:v>0.2</c:v>
                </c:pt>
                <c:pt idx="1">
                  <c:v>0.219</c:v>
                </c:pt>
                <c:pt idx="2">
                  <c:v>0.186</c:v>
                </c:pt>
                <c:pt idx="3">
                  <c:v>0.2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56E-4505-83CB-0DF2C4ADB623}"/>
            </c:ext>
          </c:extLst>
        </c:ser>
        <c:ser>
          <c:idx val="1"/>
          <c:order val="1"/>
          <c:tx>
            <c:strRef>
              <c:f>'4PV比較'!$I$3</c:f>
              <c:strCache>
                <c:ptCount val="1"/>
                <c:pt idx="0">
                  <c:v>Pt B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4PV比較'!$J$1:$M$1</c:f>
              <c:strCache>
                <c:ptCount val="4"/>
                <c:pt idx="0">
                  <c:v>RSPV</c:v>
                </c:pt>
                <c:pt idx="1">
                  <c:v>RIPV</c:v>
                </c:pt>
                <c:pt idx="2">
                  <c:v>LSPV</c:v>
                </c:pt>
                <c:pt idx="3">
                  <c:v>LIPV</c:v>
                </c:pt>
              </c:strCache>
            </c:strRef>
          </c:cat>
          <c:val>
            <c:numRef>
              <c:f>'4PV比較'!$J$3:$M$3</c:f>
              <c:numCache>
                <c:formatCode>General</c:formatCode>
                <c:ptCount val="4"/>
                <c:pt idx="0">
                  <c:v>9.7000000000000003E-2</c:v>
                </c:pt>
                <c:pt idx="1">
                  <c:v>8.4000000000000005E-2</c:v>
                </c:pt>
                <c:pt idx="2">
                  <c:v>0.105</c:v>
                </c:pt>
                <c:pt idx="3">
                  <c:v>9.500000000000000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56E-4505-83CB-0DF2C4ADB623}"/>
            </c:ext>
          </c:extLst>
        </c:ser>
        <c:ser>
          <c:idx val="2"/>
          <c:order val="2"/>
          <c:tx>
            <c:strRef>
              <c:f>'4PV比較'!$I$4</c:f>
              <c:strCache>
                <c:ptCount val="1"/>
                <c:pt idx="0">
                  <c:v>Pt C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4PV比較'!$J$1:$M$1</c:f>
              <c:strCache>
                <c:ptCount val="4"/>
                <c:pt idx="0">
                  <c:v>RSPV</c:v>
                </c:pt>
                <c:pt idx="1">
                  <c:v>RIPV</c:v>
                </c:pt>
                <c:pt idx="2">
                  <c:v>LSPV</c:v>
                </c:pt>
                <c:pt idx="3">
                  <c:v>LIPV</c:v>
                </c:pt>
              </c:strCache>
            </c:strRef>
          </c:cat>
          <c:val>
            <c:numRef>
              <c:f>'4PV比較'!$J$4:$M$4</c:f>
              <c:numCache>
                <c:formatCode>General</c:formatCode>
                <c:ptCount val="4"/>
                <c:pt idx="0">
                  <c:v>0.152</c:v>
                </c:pt>
                <c:pt idx="1">
                  <c:v>0.157</c:v>
                </c:pt>
                <c:pt idx="2">
                  <c:v>0.152</c:v>
                </c:pt>
                <c:pt idx="3">
                  <c:v>0.162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56E-4505-83CB-0DF2C4ADB623}"/>
            </c:ext>
          </c:extLst>
        </c:ser>
        <c:ser>
          <c:idx val="3"/>
          <c:order val="3"/>
          <c:tx>
            <c:strRef>
              <c:f>'4PV比較'!$I$5</c:f>
              <c:strCache>
                <c:ptCount val="1"/>
                <c:pt idx="0">
                  <c:v>Pt D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4PV比較'!$J$1:$M$1</c:f>
              <c:strCache>
                <c:ptCount val="4"/>
                <c:pt idx="0">
                  <c:v>RSPV</c:v>
                </c:pt>
                <c:pt idx="1">
                  <c:v>RIPV</c:v>
                </c:pt>
                <c:pt idx="2">
                  <c:v>LSPV</c:v>
                </c:pt>
                <c:pt idx="3">
                  <c:v>LIPV</c:v>
                </c:pt>
              </c:strCache>
            </c:strRef>
          </c:cat>
          <c:val>
            <c:numRef>
              <c:f>'4PV比較'!$J$5:$M$5</c:f>
              <c:numCache>
                <c:formatCode>General</c:formatCode>
                <c:ptCount val="4"/>
                <c:pt idx="0">
                  <c:v>0.157</c:v>
                </c:pt>
                <c:pt idx="1">
                  <c:v>0.14799999999999999</c:v>
                </c:pt>
                <c:pt idx="2">
                  <c:v>0.14799999999999999</c:v>
                </c:pt>
                <c:pt idx="3">
                  <c:v>0.133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56E-4505-83CB-0DF2C4ADB623}"/>
            </c:ext>
          </c:extLst>
        </c:ser>
        <c:ser>
          <c:idx val="4"/>
          <c:order val="4"/>
          <c:tx>
            <c:strRef>
              <c:f>'4PV比較'!$I$6</c:f>
              <c:strCache>
                <c:ptCount val="1"/>
                <c:pt idx="0">
                  <c:v>Pt E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4PV比較'!$J$1:$M$1</c:f>
              <c:strCache>
                <c:ptCount val="4"/>
                <c:pt idx="0">
                  <c:v>RSPV</c:v>
                </c:pt>
                <c:pt idx="1">
                  <c:v>RIPV</c:v>
                </c:pt>
                <c:pt idx="2">
                  <c:v>LSPV</c:v>
                </c:pt>
                <c:pt idx="3">
                  <c:v>LIPV</c:v>
                </c:pt>
              </c:strCache>
            </c:strRef>
          </c:cat>
          <c:val>
            <c:numRef>
              <c:f>'4PV比較'!$J$6:$M$6</c:f>
              <c:numCache>
                <c:formatCode>General</c:formatCode>
                <c:ptCount val="4"/>
                <c:pt idx="0">
                  <c:v>0.114</c:v>
                </c:pt>
                <c:pt idx="1">
                  <c:v>0.124</c:v>
                </c:pt>
                <c:pt idx="2">
                  <c:v>0.11</c:v>
                </c:pt>
                <c:pt idx="3">
                  <c:v>0.118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56E-4505-83CB-0DF2C4ADB6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02180287"/>
        <c:axId val="1902183167"/>
      </c:lineChart>
      <c:catAx>
        <c:axId val="19021802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902183167"/>
        <c:crosses val="autoZero"/>
        <c:auto val="1"/>
        <c:lblAlgn val="ctr"/>
        <c:lblOffset val="100"/>
        <c:noMultiLvlLbl val="0"/>
      </c:catAx>
      <c:valAx>
        <c:axId val="190218316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902180287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E048C9-ECCB-4A17-8CCE-DE3D21083F80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120B1D-1543-4E8F-BF14-F09D60209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8949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0F83ED-3014-E7B3-1DF2-F10E60AB39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4F683F-C07A-DC89-4985-DEB2EB6079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B4D0B9-8807-17BF-ED2B-9FF71BC57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1FC72-1DEF-33C0-7368-7033F6353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974D39-7897-57DA-8FD5-6EFF012FF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256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0A0D0-0659-F011-C4F2-20C8A9245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AA5D75C-74BE-1746-C9B7-C18741EF0E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536F9E-62DB-36ED-30DB-48E39A7F2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1A376E-7FA7-BF63-C68B-AE295F096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00B413-9A8C-DCC5-CEC0-36B4D110A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587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70D2F11-48DA-95C2-6834-29131175C9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E3FCDA-DFA9-DC39-0446-C4983615E3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75A5E-4B28-49F9-F541-2D1524F7A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B6DED5-039B-649B-5F32-DFF7F95D5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AB572F-029D-FF2F-57F0-A49BBA0EC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03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076FC5-6F64-8B8A-3BC3-F63C5C74C6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A75DF2-FF29-4D0A-2BB2-A982915DEB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92A26A-C5EC-4FB1-8020-948CEE741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0EC053-90CE-3569-BCEF-6277CAA10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BBD742-AF0F-DAF1-4516-311BB0289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802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8E514D-BFE0-25EC-3FE5-D687A3731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5109AA-5B99-47B1-A810-B2E8C2548C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3ADC29-1A90-D383-7655-62AB511DF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16683D-F2F2-22E4-BA75-7F81D642C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7973DA-DFED-49D9-873E-ECF2991F8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22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84BF36-AA92-D3F5-C575-ED0A7D9F16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7BD42E-09F4-769A-3C05-0996C413E8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58F90C9-DEFF-47F8-C103-DDF1A4FBD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D0F5A73-318D-30EE-832A-1B4F7C552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45C8D84-3AD3-42AC-B516-A2DA7462C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53592F4-8FC7-9979-DC78-9995531EE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1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2037B7-0AF1-069F-F81E-86ADFD642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BF33E2-E4AF-6940-B960-4FD61EAB01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6CEAEE8-CAA0-A530-3C57-A2B56F654C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89AA45D-8FE1-C6B9-FCE7-B475CFFFDF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0727C9F-28CA-8890-9A49-EA3AF68DE1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F1D6B62-4BA3-D9AB-FA74-32360F8CC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38C7BC4-B787-5012-C9DE-BFB9D05ED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79FD61E-E935-763B-BA36-79D59D221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048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50C970-B3E6-B6DD-28C1-0B33B4134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D0D24DB-480D-BB6A-9155-E5730E94E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3200D38-3864-107D-9BFD-77ADB859F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3C1839B-1052-F4FA-CE6F-CBCDE0E31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952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2A053B8-B0E7-A636-B107-A0B7CE864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EE15BCE-8785-5DD7-1FE3-6894E8594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A269A1-4330-7D63-123D-8FB4F329D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053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3B118E-AD72-C8D4-91F2-90EF4A267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C24F3E-AEDB-E9F1-510A-49E8DE237C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8FB2F6-F2AF-B479-E643-D24DAC4EA6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47C4B4C-25AA-66F6-A2AA-E7A5EB99B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478484E-BEAD-1A87-C243-8F34ACCC5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1B0293-B15F-20C1-E8B4-AC7A3B1F8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3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729A02-537B-BB19-760A-957365028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F019A42-8501-0505-BCA6-7FB07088F6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89E2AD-A3E6-7C44-DE08-E7693127C4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1044AE8-F2DE-DB5A-0982-ACD3A3B51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586D3F-F961-69FE-4B50-B03FA4C6C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8407CB-DF30-A765-6192-3C5641733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348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BD2EA8A-86DA-4571-320D-251B28B79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142C7E-06F5-9558-8AB2-7C65148428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C4A95B-B338-DF66-65FA-9BD4B55002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4D61AC-7675-9CE1-FC8A-36B775A09B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1AA20C-078A-155A-4464-ABEE8E8CD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952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w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wmf"/><Relationship Id="rId10" Type="http://schemas.openxmlformats.org/officeDocument/2006/relationships/chart" Target="../charts/chart1.xml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9B5BD578-021D-5042-632A-1D352CED7D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3370163"/>
              </p:ext>
            </p:extLst>
          </p:nvPr>
        </p:nvGraphicFramePr>
        <p:xfrm>
          <a:off x="7826352" y="1072453"/>
          <a:ext cx="3568700" cy="347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567960" imgH="3479040" progId="">
                  <p:embed/>
                </p:oleObj>
              </mc:Choice>
              <mc:Fallback>
                <p:oleObj r:id="rId2" imgW="3567960" imgH="3479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826352" y="1072453"/>
                        <a:ext cx="3568700" cy="347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7B436421-F637-2591-BE5D-DF43F79A0B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6945959"/>
              </p:ext>
            </p:extLst>
          </p:nvPr>
        </p:nvGraphicFramePr>
        <p:xfrm>
          <a:off x="4257652" y="1072453"/>
          <a:ext cx="3568700" cy="347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567960" imgH="3479040" progId="">
                  <p:embed/>
                </p:oleObj>
              </mc:Choice>
              <mc:Fallback>
                <p:oleObj r:id="rId4" imgW="3567960" imgH="3479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57652" y="1072453"/>
                        <a:ext cx="3568700" cy="347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B2231F2-4F51-4E14-C7DB-BFFCA882A53A}"/>
              </a:ext>
            </a:extLst>
          </p:cNvPr>
          <p:cNvSpPr txBox="1"/>
          <p:nvPr/>
        </p:nvSpPr>
        <p:spPr>
          <a:xfrm>
            <a:off x="8443736" y="1194074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EA0FBE6-838D-FA40-0552-C204B5935E46}"/>
              </a:ext>
            </a:extLst>
          </p:cNvPr>
          <p:cNvSpPr txBox="1"/>
          <p:nvPr/>
        </p:nvSpPr>
        <p:spPr>
          <a:xfrm>
            <a:off x="9058276" y="1396257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36590C5-73FC-3C29-3DD8-B757491724C6}"/>
              </a:ext>
            </a:extLst>
          </p:cNvPr>
          <p:cNvSpPr txBox="1"/>
          <p:nvPr/>
        </p:nvSpPr>
        <p:spPr>
          <a:xfrm>
            <a:off x="9751474" y="1194074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5757B8F-27C3-E32F-A5AC-1BDD5FE817AF}"/>
              </a:ext>
            </a:extLst>
          </p:cNvPr>
          <p:cNvSpPr txBox="1"/>
          <p:nvPr/>
        </p:nvSpPr>
        <p:spPr>
          <a:xfrm>
            <a:off x="10452920" y="303763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a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4CE0F03-785A-5116-8B21-F26588C1C4DC}"/>
              </a:ext>
            </a:extLst>
          </p:cNvPr>
          <p:cNvSpPr txBox="1"/>
          <p:nvPr/>
        </p:nvSpPr>
        <p:spPr>
          <a:xfrm>
            <a:off x="5175652" y="1887248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11A1A19-2A07-AC21-8A8B-F55C773EAD72}"/>
              </a:ext>
            </a:extLst>
          </p:cNvPr>
          <p:cNvSpPr txBox="1"/>
          <p:nvPr/>
        </p:nvSpPr>
        <p:spPr>
          <a:xfrm>
            <a:off x="5642709" y="192228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6D58BBB-7A24-CB37-1DA8-ABF4951CDFB6}"/>
              </a:ext>
            </a:extLst>
          </p:cNvPr>
          <p:cNvSpPr txBox="1"/>
          <p:nvPr/>
        </p:nvSpPr>
        <p:spPr>
          <a:xfrm>
            <a:off x="6335907" y="1720099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D7A8BF3-CA08-5997-5DBC-BE1B4F9902C7}"/>
              </a:ext>
            </a:extLst>
          </p:cNvPr>
          <p:cNvSpPr txBox="1"/>
          <p:nvPr/>
        </p:nvSpPr>
        <p:spPr>
          <a:xfrm>
            <a:off x="5406005" y="777225"/>
            <a:ext cx="981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uring AF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99E47E5-D0FC-B17E-8DB5-47A1F5D66020}"/>
              </a:ext>
            </a:extLst>
          </p:cNvPr>
          <p:cNvSpPr txBox="1"/>
          <p:nvPr/>
        </p:nvSpPr>
        <p:spPr>
          <a:xfrm>
            <a:off x="8602949" y="589854"/>
            <a:ext cx="17748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ost PVI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fter cardioversion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A327002B-1D07-37BD-3DD7-7F950C6324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4593694"/>
              </p:ext>
            </p:extLst>
          </p:nvPr>
        </p:nvGraphicFramePr>
        <p:xfrm>
          <a:off x="156081" y="4114592"/>
          <a:ext cx="4025371" cy="21321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10699756" imgH="5666970" progId="">
                  <p:embed/>
                </p:oleObj>
              </mc:Choice>
              <mc:Fallback>
                <p:oleObj r:id="rId6" imgW="10699756" imgH="5666970" progId="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5A051A79-6867-61E0-4A1B-C16AC07999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6081" y="4114592"/>
                        <a:ext cx="4025371" cy="21321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DCE9F8B9-A396-7255-4050-E0A106B417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2273516"/>
              </p:ext>
            </p:extLst>
          </p:nvPr>
        </p:nvGraphicFramePr>
        <p:xfrm>
          <a:off x="156082" y="1088072"/>
          <a:ext cx="4025371" cy="30265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8956016" imgH="6733425" progId="">
                  <p:embed/>
                </p:oleObj>
              </mc:Choice>
              <mc:Fallback>
                <p:oleObj r:id="rId8" imgW="8956016" imgH="6733425" progId="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485CD612-33EF-7E04-2AF8-3B215A94D1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6082" y="1088072"/>
                        <a:ext cx="4025371" cy="30265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0FF5ECF-CDE0-B8DC-2D44-41FC4FF067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9599452"/>
              </p:ext>
            </p:extLst>
          </p:nvPr>
        </p:nvGraphicFramePr>
        <p:xfrm>
          <a:off x="4825300" y="4940924"/>
          <a:ext cx="6554554" cy="1815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4437F62-0680-1145-AA9F-F7E7522AB0B8}"/>
              </a:ext>
            </a:extLst>
          </p:cNvPr>
          <p:cNvSpPr txBox="1"/>
          <p:nvPr/>
        </p:nvSpPr>
        <p:spPr>
          <a:xfrm>
            <a:off x="9349442" y="102704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3726565-893D-F595-1063-812912736975}"/>
              </a:ext>
            </a:extLst>
          </p:cNvPr>
          <p:cNvSpPr txBox="1"/>
          <p:nvPr/>
        </p:nvSpPr>
        <p:spPr>
          <a:xfrm>
            <a:off x="4908114" y="4777687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/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E1A1BD8-0AD8-5D8C-804E-EEEF5B9C6FB1}"/>
              </a:ext>
            </a:extLst>
          </p:cNvPr>
          <p:cNvSpPr txBox="1"/>
          <p:nvPr/>
        </p:nvSpPr>
        <p:spPr>
          <a:xfrm rot="16200000">
            <a:off x="3926331" y="5513901"/>
            <a:ext cx="1626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V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wave velocit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F98AB75-2B24-31F7-3C10-A8D90CA1D334}"/>
              </a:ext>
            </a:extLst>
          </p:cNvPr>
          <p:cNvSpPr txBox="1"/>
          <p:nvPr/>
        </p:nvSpPr>
        <p:spPr>
          <a:xfrm>
            <a:off x="4572605" y="455546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E198E3F-5F49-1485-AC71-34E39784567D}"/>
              </a:ext>
            </a:extLst>
          </p:cNvPr>
          <p:cNvSpPr txBox="1"/>
          <p:nvPr/>
        </p:nvSpPr>
        <p:spPr>
          <a:xfrm>
            <a:off x="210155" y="7168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C4E978E-9DD4-88A4-597C-FD0D564E9AD8}"/>
              </a:ext>
            </a:extLst>
          </p:cNvPr>
          <p:cNvSpPr txBox="1"/>
          <p:nvPr/>
        </p:nvSpPr>
        <p:spPr>
          <a:xfrm>
            <a:off x="4213058" y="7168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9491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9</TotalTime>
  <Words>27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0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田 一樹</dc:creator>
  <cp:lastModifiedBy>一樹 野田</cp:lastModifiedBy>
  <cp:revision>83</cp:revision>
  <dcterms:created xsi:type="dcterms:W3CDTF">2023-01-02T05:59:21Z</dcterms:created>
  <dcterms:modified xsi:type="dcterms:W3CDTF">2025-08-03T06:22:40Z</dcterms:modified>
</cp:coreProperties>
</file>